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1" r:id="rId2"/>
  </p:sldIdLst>
  <p:sldSz cx="6840538" cy="9144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A0000"/>
    <a:srgbClr val="233E6F"/>
    <a:srgbClr val="2A4B86"/>
    <a:srgbClr val="820000"/>
    <a:srgbClr val="F8AEAE"/>
    <a:srgbClr val="9393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42" autoAdjust="0"/>
    <p:restoredTop sz="96224" autoAdjust="0"/>
  </p:normalViewPr>
  <p:slideViewPr>
    <p:cSldViewPr snapToGrid="0">
      <p:cViewPr varScale="1">
        <p:scale>
          <a:sx n="70" d="100"/>
          <a:sy n="70" d="100"/>
        </p:scale>
        <p:origin x="321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CC8D25-303F-4077-995E-227DA256540A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143000"/>
            <a:ext cx="2308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345B17-916C-412B-82F5-AEF5ADF5576D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65707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CA" dirty="0"/>
              <a:t>Sup table 2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345B17-916C-412B-82F5-AEF5ADF5576D}" type="slidenum">
              <a:rPr lang="fr-BE" smtClean="0"/>
              <a:t>1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4094409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96484"/>
            <a:ext cx="5814457" cy="318346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802717"/>
            <a:ext cx="5130404" cy="220768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190761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889702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86834"/>
            <a:ext cx="1474991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86834"/>
            <a:ext cx="4339466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652841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744317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279653"/>
            <a:ext cx="5899964" cy="3803649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119286"/>
            <a:ext cx="5899964" cy="20002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8825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238658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86836"/>
            <a:ext cx="5899964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241551"/>
            <a:ext cx="2893868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340100"/>
            <a:ext cx="2893868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241551"/>
            <a:ext cx="2908120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340100"/>
            <a:ext cx="2908120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58807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91157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76084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316569"/>
            <a:ext cx="3463022" cy="6498167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900577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316569"/>
            <a:ext cx="3463022" cy="6498167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030894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86836"/>
            <a:ext cx="5899964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434167"/>
            <a:ext cx="5899964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475136"/>
            <a:ext cx="2308682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632263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4">
            <a:extLst>
              <a:ext uri="{FF2B5EF4-FFF2-40B4-BE49-F238E27FC236}">
                <a16:creationId xmlns:a16="http://schemas.microsoft.com/office/drawing/2014/main" id="{E28AEDF1-32DE-F87C-7C64-0760796F40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8653126"/>
              </p:ext>
            </p:extLst>
          </p:nvPr>
        </p:nvGraphicFramePr>
        <p:xfrm>
          <a:off x="118565" y="60960"/>
          <a:ext cx="6603408" cy="9004176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782187">
                  <a:extLst>
                    <a:ext uri="{9D8B030D-6E8A-4147-A177-3AD203B41FA5}">
                      <a16:colId xmlns:a16="http://schemas.microsoft.com/office/drawing/2014/main" val="2086277466"/>
                    </a:ext>
                  </a:extLst>
                </a:gridCol>
                <a:gridCol w="750627">
                  <a:extLst>
                    <a:ext uri="{9D8B030D-6E8A-4147-A177-3AD203B41FA5}">
                      <a16:colId xmlns:a16="http://schemas.microsoft.com/office/drawing/2014/main" val="3009751787"/>
                    </a:ext>
                  </a:extLst>
                </a:gridCol>
                <a:gridCol w="846161">
                  <a:extLst>
                    <a:ext uri="{9D8B030D-6E8A-4147-A177-3AD203B41FA5}">
                      <a16:colId xmlns:a16="http://schemas.microsoft.com/office/drawing/2014/main" val="2150354374"/>
                    </a:ext>
                  </a:extLst>
                </a:gridCol>
                <a:gridCol w="3179929">
                  <a:extLst>
                    <a:ext uri="{9D8B030D-6E8A-4147-A177-3AD203B41FA5}">
                      <a16:colId xmlns:a16="http://schemas.microsoft.com/office/drawing/2014/main" val="219911373"/>
                    </a:ext>
                  </a:extLst>
                </a:gridCol>
                <a:gridCol w="1044504">
                  <a:extLst>
                    <a:ext uri="{9D8B030D-6E8A-4147-A177-3AD203B41FA5}">
                      <a16:colId xmlns:a16="http://schemas.microsoft.com/office/drawing/2014/main" val="4179746898"/>
                    </a:ext>
                  </a:extLst>
                </a:gridCol>
              </a:tblGrid>
              <a:tr h="292810">
                <a:tc gridSpan="5">
                  <a:txBody>
                    <a:bodyPr/>
                    <a:lstStyle/>
                    <a:p>
                      <a:pPr marL="0" marR="0" lvl="0" indent="0" algn="ctr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 profile of apoptotic SCC-9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rgbClr val="2A4B8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rgbClr val="2A4B8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rgbClr val="2A4B8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BE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rgbClr val="2A4B8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0058160"/>
                  </a:ext>
                </a:extLst>
              </a:tr>
              <a:tr h="268406"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gene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seq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fr-BE" sz="1000" b="1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d change</a:t>
                      </a:r>
                    </a:p>
                  </a:txBody>
                  <a:tcPr>
                    <a:solidFill>
                      <a:srgbClr val="2A4B8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1143893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525622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51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T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-akt murine thymoma viral oncogene homolog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7636510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233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28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G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-associated athanogene 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4664820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64429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3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-associated X prote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3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7414797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935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9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-cell CLL/lymphoma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0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5846901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169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13857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L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-lik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3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9028625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4696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65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L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-like 11 (apoptosis facilitator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88020380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4100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0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L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-like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36352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6962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1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RC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culoviral IAP repeat containing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24068716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64649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3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NIP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/adenovirus E1B 19KDa interacting protein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668911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312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3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NIP3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/adenovirus E1B 19KDa interacting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rotein 3-like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9844024"/>
                  </a:ext>
                </a:extLst>
              </a:tr>
              <a:tr h="322091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249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3329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 1, apoptosis-related cysteine peptidase (interleukin 1, beta, convertas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2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2282169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411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3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 3, apoptosis-related cysteine peptid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6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6900992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2133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43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 5, apoptosis-related cysteine peptid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5099775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92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 7, apoptosis-related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steine peptidase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9032657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3295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2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ase 9, apoptosis-related cysteine peptida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8406742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3553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27 molecu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8410082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922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007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0L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0 ligan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6.3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0446391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0149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70 molecu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7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96986455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24912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2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DE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death-inducing DFFA-like effector 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3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5713533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6426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44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DE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death-inducing DFFA-like effector 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04286917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385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8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AD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P2 and RIPK1 domain containing adaptor with death doma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1684857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4370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89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chrome c, somat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1121888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696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1988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L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lo, IAP-binding mitochondrial prote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2464187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200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06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L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 ligand (TNF superfamily, member 6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9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5000895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804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9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DD45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wth arrest and DNA-damage-inducible, alph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94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4227957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872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8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rakiri, BCL2 interacting protein (contains only BH3 domain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7613837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6431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08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GF1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ulin-like growth factor 1 recep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9911578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937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057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leukin 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1301495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059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T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mphotoxin alpha (TNF superfamily, member 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8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4659962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1037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8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PK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eptor-interacting serine-threonine kinase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21879879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2415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05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necrosis fac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18775375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66166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8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RSF10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necrosis factor receptor superfamily, member 10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6973543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8179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25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RSF11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necrosis factor receptor superfamily, member 11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8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15853850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7138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0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RSF1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necrosis factor receptor superfamily, member 1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4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042179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46252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79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RSF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necrosis factor receptor superfamily, member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5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8808543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7389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5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RSF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necrosis factor receptor superfamily, member</a:t>
                      </a:r>
                      <a:r>
                        <a:rPr lang="fr-BE" sz="8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9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10127966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4782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8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SF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68406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necrosis factor (ligand) superfamily, member 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8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1049224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52396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54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BP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protein p53 binding protein,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3198545"/>
                  </a:ext>
                </a:extLst>
              </a:tr>
              <a:tr h="204967"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. 46099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78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D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FRSF 1A-associated via death doma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BE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3961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81770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36</TotalTime>
  <Words>578</Words>
  <Application>Microsoft Office PowerPoint</Application>
  <PresentationFormat>Personnalisé</PresentationFormat>
  <Paragraphs>20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wraa</dc:creator>
  <cp:lastModifiedBy>Abdelhabib Semlali</cp:lastModifiedBy>
  <cp:revision>568</cp:revision>
  <cp:lastPrinted>2022-12-05T14:26:03Z</cp:lastPrinted>
  <dcterms:created xsi:type="dcterms:W3CDTF">2019-02-19T20:27:18Z</dcterms:created>
  <dcterms:modified xsi:type="dcterms:W3CDTF">2024-04-05T15:21:28Z</dcterms:modified>
</cp:coreProperties>
</file>